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1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37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0A279-D048-411B-9C2B-A3F4E84AA23C}" type="datetimeFigureOut">
              <a:rPr lang="es-ES" smtClean="0"/>
              <a:t>23/08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6A6AC-9334-4217-A504-1EBCE96430F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8548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0A279-D048-411B-9C2B-A3F4E84AA23C}" type="datetimeFigureOut">
              <a:rPr lang="es-ES" smtClean="0"/>
              <a:t>23/08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6A6AC-9334-4217-A504-1EBCE96430F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6711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0A279-D048-411B-9C2B-A3F4E84AA23C}" type="datetimeFigureOut">
              <a:rPr lang="es-ES" smtClean="0"/>
              <a:t>23/08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6A6AC-9334-4217-A504-1EBCE96430F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4544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0A279-D048-411B-9C2B-A3F4E84AA23C}" type="datetimeFigureOut">
              <a:rPr lang="es-ES" smtClean="0"/>
              <a:t>23/08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6A6AC-9334-4217-A504-1EBCE96430F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4038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0A279-D048-411B-9C2B-A3F4E84AA23C}" type="datetimeFigureOut">
              <a:rPr lang="es-ES" smtClean="0"/>
              <a:t>23/08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6A6AC-9334-4217-A504-1EBCE96430F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02757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0A279-D048-411B-9C2B-A3F4E84AA23C}" type="datetimeFigureOut">
              <a:rPr lang="es-ES" smtClean="0"/>
              <a:t>23/08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6A6AC-9334-4217-A504-1EBCE96430F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857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0A279-D048-411B-9C2B-A3F4E84AA23C}" type="datetimeFigureOut">
              <a:rPr lang="es-ES" smtClean="0"/>
              <a:t>23/08/20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6A6AC-9334-4217-A504-1EBCE96430F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8559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0A279-D048-411B-9C2B-A3F4E84AA23C}" type="datetimeFigureOut">
              <a:rPr lang="es-ES" smtClean="0"/>
              <a:t>23/08/20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6A6AC-9334-4217-A504-1EBCE96430F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75409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0A279-D048-411B-9C2B-A3F4E84AA23C}" type="datetimeFigureOut">
              <a:rPr lang="es-ES" smtClean="0"/>
              <a:t>23/08/20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6A6AC-9334-4217-A504-1EBCE96430F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31079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0A279-D048-411B-9C2B-A3F4E84AA23C}" type="datetimeFigureOut">
              <a:rPr lang="es-ES" smtClean="0"/>
              <a:t>23/08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6A6AC-9334-4217-A504-1EBCE96430F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7286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E0A279-D048-411B-9C2B-A3F4E84AA23C}" type="datetimeFigureOut">
              <a:rPr lang="es-ES" smtClean="0"/>
              <a:t>23/08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86A6AC-9334-4217-A504-1EBCE96430F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1119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E0A279-D048-411B-9C2B-A3F4E84AA23C}" type="datetimeFigureOut">
              <a:rPr lang="es-ES" smtClean="0"/>
              <a:t>23/08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86A6AC-9334-4217-A504-1EBCE96430F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5331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/>
          <a:srcRect l="11528" t="14616" r="24722" b="8333"/>
          <a:stretch/>
        </p:blipFill>
        <p:spPr>
          <a:xfrm>
            <a:off x="1991169" y="104519"/>
            <a:ext cx="8111218" cy="5310286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3"/>
          <a:srcRect l="36459" t="71026" r="14861" b="9615"/>
          <a:stretch/>
        </p:blipFill>
        <p:spPr>
          <a:xfrm>
            <a:off x="3426828" y="5542992"/>
            <a:ext cx="5363018" cy="1007234"/>
          </a:xfrm>
          <a:prstGeom prst="rect">
            <a:avLst/>
          </a:prstGeom>
          <a:ln>
            <a:solidFill>
              <a:srgbClr val="FF0000"/>
            </a:solidFill>
          </a:ln>
        </p:spPr>
      </p:pic>
      <p:sp>
        <p:nvSpPr>
          <p:cNvPr id="6" name="CuadroTexto 5"/>
          <p:cNvSpPr txBox="1"/>
          <p:nvPr/>
        </p:nvSpPr>
        <p:spPr>
          <a:xfrm>
            <a:off x="182216" y="6507450"/>
            <a:ext cx="112976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err="1" smtClean="0"/>
              <a:t>Supplementary</a:t>
            </a:r>
            <a:r>
              <a:rPr lang="es-ES" b="1" dirty="0" smtClean="0"/>
              <a:t> Figure S7</a:t>
            </a:r>
            <a:r>
              <a:rPr lang="es-ES" b="1" dirty="0"/>
              <a:t>.  GRAMD4-STRING </a:t>
            </a:r>
            <a:r>
              <a:rPr lang="es-ES" b="1" dirty="0" err="1"/>
              <a:t>scheme</a:t>
            </a:r>
            <a:r>
              <a:rPr lang="es-ES" b="1" dirty="0"/>
              <a:t> of </a:t>
            </a:r>
            <a:r>
              <a:rPr lang="es-ES" b="1" dirty="0" err="1"/>
              <a:t>protein-protein</a:t>
            </a:r>
            <a:r>
              <a:rPr lang="es-ES" b="1" dirty="0"/>
              <a:t> </a:t>
            </a:r>
            <a:r>
              <a:rPr lang="es-ES" b="1" dirty="0" err="1"/>
              <a:t>interaction</a:t>
            </a:r>
            <a:r>
              <a:rPr lang="es-ES" b="1" dirty="0"/>
              <a:t>. </a:t>
            </a:r>
            <a:r>
              <a:rPr lang="es-ES" dirty="0" err="1"/>
              <a:t>Taken</a:t>
            </a:r>
            <a:r>
              <a:rPr lang="es-ES" dirty="0"/>
              <a:t> from https://string-db.org/</a:t>
            </a:r>
          </a:p>
        </p:txBody>
      </p:sp>
    </p:spTree>
    <p:extLst>
      <p:ext uri="{BB962C8B-B14F-4D97-AF65-F5344CB8AC3E}">
        <p14:creationId xmlns:p14="http://schemas.microsoft.com/office/powerpoint/2010/main" val="29879527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lian</dc:creator>
  <cp:lastModifiedBy>Julian</cp:lastModifiedBy>
  <cp:revision>3</cp:revision>
  <dcterms:created xsi:type="dcterms:W3CDTF">2021-04-27T17:20:52Z</dcterms:created>
  <dcterms:modified xsi:type="dcterms:W3CDTF">2021-08-23T16:14:39Z</dcterms:modified>
</cp:coreProperties>
</file>